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484" y="1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tlas\users\christiane.margue\Working%20folder%20(backup%2006-2011)\Publications\miR-211%202012-2013\diff.%20documents\PLOSOne-miR-211\CM140%20-%20siMITF%20INV+MIG+PROL%20FigureS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atlas\users\christiane.margue\Working%20folder%20(backup%2006-2011)\Publications\miR-211%202012-2013\diff.%20documents\PLOSOne-miR-211\CM140%20-%20siMITF%20INV+MIG+PROL%20FigureS6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atlas\users\christiane.margue\Working%20folder%20(backup%2006-2011)\Publications\miR-211%202012-2013\diff.%20documents\PLOSOne-miR-211\CM140%20-%20siMITF%20INV+MIG+PROL%20FigureS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atlas\users\christiane.margue\Working%20folder%20(backup%2006-2011)\Publications\miR-211%202012\diff.%20documents\JID%20-211%20paper\Figures\Copy%20of%20CM140%20-%20siMITF%20INV+MIG+PROL%20Figure%20for%20rebuttal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atlas\users\christiane.margue\Working%20folder%20(backup%2006-2011)\Publications\miR-211%202012\diff.%20documents\JID%20-211%20paper\Figures\Copy%20of%20CM140%20-%20siMITF%20INV+MIG+PROL%20Figure%20for%20rebutt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900"/>
            </a:pPr>
            <a:r>
              <a:rPr lang="en-US" sz="900"/>
              <a:t>MITF expression </a:t>
            </a:r>
            <a:r>
              <a:rPr lang="en-US" sz="900" baseline="0"/>
              <a:t>after siMITF transfection </a:t>
            </a:r>
            <a:endParaRPr lang="en-US" sz="900"/>
          </a:p>
        </c:rich>
      </c:tx>
      <c:layout>
        <c:manualLayout>
          <c:xMode val="edge"/>
          <c:yMode val="edge"/>
          <c:x val="0.27008846194342601"/>
          <c:y val="5.0864059649982044E-2"/>
        </c:manualLayout>
      </c:layout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qPCR!$A$3</c:f>
              <c:strCache>
                <c:ptCount val="1"/>
                <c:pt idx="0">
                  <c:v>NC-24h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solidFill>
                <a:srgbClr val="002060"/>
              </a:solidFill>
            </a:ln>
          </c:spPr>
          <c:dPt>
            <c:idx val="0"/>
            <c:spPr>
              <a:solidFill>
                <a:srgbClr val="002060"/>
              </a:solidFill>
              <a:ln>
                <a:solidFill>
                  <a:srgbClr val="002060"/>
                </a:solidFill>
              </a:ln>
            </c:spPr>
          </c:dPt>
          <c:dPt>
            <c:idx val="1"/>
            <c:spPr>
              <a:solidFill>
                <a:srgbClr val="002060"/>
              </a:solidFill>
              <a:ln>
                <a:solidFill>
                  <a:srgbClr val="002060"/>
                </a:solidFill>
              </a:ln>
            </c:spPr>
          </c:dPt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B$3,qPCR!$E$3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qPCR!$A$4</c:f>
              <c:strCache>
                <c:ptCount val="1"/>
                <c:pt idx="0">
                  <c:v>siMITF-24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B$4,qPCR!$E$4)</c:f>
              <c:numCache>
                <c:formatCode>0.00</c:formatCode>
                <c:ptCount val="2"/>
                <c:pt idx="0">
                  <c:v>0.18556544629485341</c:v>
                </c:pt>
                <c:pt idx="1">
                  <c:v>0.19411721863447817</c:v>
                </c:pt>
              </c:numCache>
            </c:numRef>
          </c:val>
        </c:ser>
        <c:ser>
          <c:idx val="2"/>
          <c:order val="2"/>
          <c:tx>
            <c:strRef>
              <c:f>qPCR!$A$5</c:f>
              <c:strCache>
                <c:ptCount val="1"/>
                <c:pt idx="0">
                  <c:v>NC-48h</c:v>
                </c:pt>
              </c:strCache>
            </c:strRef>
          </c:tx>
          <c:spPr>
            <a:solidFill>
              <a:srgbClr val="002060"/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B$5,qPCR!$E$5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3"/>
          <c:order val="3"/>
          <c:tx>
            <c:strRef>
              <c:f>qPCR!$A$6</c:f>
              <c:strCache>
                <c:ptCount val="1"/>
                <c:pt idx="0">
                  <c:v>siMITF-48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B$6,qPCR!$E$6)</c:f>
              <c:numCache>
                <c:formatCode>0.00</c:formatCode>
                <c:ptCount val="2"/>
                <c:pt idx="0">
                  <c:v>0.19682699413904714</c:v>
                </c:pt>
                <c:pt idx="1">
                  <c:v>0.26425451024862895</c:v>
                </c:pt>
              </c:numCache>
            </c:numRef>
          </c:val>
        </c:ser>
        <c:ser>
          <c:idx val="4"/>
          <c:order val="4"/>
          <c:tx>
            <c:strRef>
              <c:f>qPCR!$A$7</c:f>
              <c:strCache>
                <c:ptCount val="1"/>
                <c:pt idx="0">
                  <c:v>NC-72h</c:v>
                </c:pt>
              </c:strCache>
            </c:strRef>
          </c:tx>
          <c:spPr>
            <a:solidFill>
              <a:srgbClr val="002060"/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B$7,qPCR!$E$7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5"/>
          <c:order val="5"/>
          <c:tx>
            <c:strRef>
              <c:f>qPCR!$A$8</c:f>
              <c:strCache>
                <c:ptCount val="1"/>
                <c:pt idx="0">
                  <c:v>siMITF-72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B$8,qPCR!$E$8)</c:f>
              <c:numCache>
                <c:formatCode>0.00</c:formatCode>
                <c:ptCount val="2"/>
                <c:pt idx="0">
                  <c:v>0.20949678373967129</c:v>
                </c:pt>
                <c:pt idx="1">
                  <c:v>0.23981602983636757</c:v>
                </c:pt>
              </c:numCache>
            </c:numRef>
          </c:val>
        </c:ser>
        <c:dLbls/>
        <c:axId val="38200448"/>
        <c:axId val="38201984"/>
      </c:barChart>
      <c:catAx>
        <c:axId val="38200448"/>
        <c:scaling>
          <c:orientation val="minMax"/>
        </c:scaling>
        <c:axPos val="b"/>
        <c:tickLblPos val="nextTo"/>
        <c:crossAx val="38201984"/>
        <c:crosses val="autoZero"/>
        <c:auto val="1"/>
        <c:lblAlgn val="ctr"/>
        <c:lblOffset val="100"/>
      </c:catAx>
      <c:valAx>
        <c:axId val="38201984"/>
        <c:scaling>
          <c:orientation val="minMax"/>
        </c:scaling>
        <c:axPos val="l"/>
        <c:numFmt formatCode="0.0" sourceLinked="0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38200448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500" b="1"/>
            </a:pPr>
            <a:endParaRPr lang="en-US"/>
          </a:p>
        </c:txPr>
      </c:dTable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900"/>
            </a:pPr>
            <a:r>
              <a:rPr lang="en-US" sz="900" dirty="0" smtClean="0"/>
              <a:t>miR-211 </a:t>
            </a:r>
            <a:r>
              <a:rPr lang="en-US" sz="900" dirty="0"/>
              <a:t>expression </a:t>
            </a:r>
            <a:r>
              <a:rPr lang="en-US" sz="900" baseline="0" dirty="0"/>
              <a:t>after </a:t>
            </a:r>
            <a:r>
              <a:rPr lang="en-US" sz="900" baseline="0" dirty="0" err="1"/>
              <a:t>siMITF</a:t>
            </a:r>
            <a:r>
              <a:rPr lang="en-US" sz="900" baseline="0" dirty="0"/>
              <a:t> transfection </a:t>
            </a:r>
            <a:endParaRPr lang="en-US" sz="900" dirty="0"/>
          </a:p>
        </c:rich>
      </c:tx>
      <c:layout>
        <c:manualLayout>
          <c:xMode val="edge"/>
          <c:yMode val="edge"/>
          <c:x val="0.26921033012013423"/>
          <c:y val="2.9065176942846879E-2"/>
        </c:manualLayout>
      </c:layout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qPCR!$A$3</c:f>
              <c:strCache>
                <c:ptCount val="1"/>
                <c:pt idx="0">
                  <c:v>NC-24h</c:v>
                </c:pt>
              </c:strCache>
            </c:strRef>
          </c:tx>
          <c:spPr>
            <a:solidFill>
              <a:srgbClr val="002060"/>
            </a:solidFill>
          </c:spPr>
          <c:dPt>
            <c:idx val="0"/>
          </c:dPt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C$3,qPCR!$F$3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qPCR!$A$4</c:f>
              <c:strCache>
                <c:ptCount val="1"/>
                <c:pt idx="0">
                  <c:v>siMITF-24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C$4,qPCR!$F$4)</c:f>
              <c:numCache>
                <c:formatCode>0.00</c:formatCode>
                <c:ptCount val="2"/>
                <c:pt idx="0">
                  <c:v>0.70710678118654746</c:v>
                </c:pt>
                <c:pt idx="1">
                  <c:v>0.5</c:v>
                </c:pt>
              </c:numCache>
            </c:numRef>
          </c:val>
        </c:ser>
        <c:ser>
          <c:idx val="2"/>
          <c:order val="2"/>
          <c:tx>
            <c:strRef>
              <c:f>qPCR!$A$5</c:f>
              <c:strCache>
                <c:ptCount val="1"/>
                <c:pt idx="0">
                  <c:v>NC-48h</c:v>
                </c:pt>
              </c:strCache>
            </c:strRef>
          </c:tx>
          <c:spPr>
            <a:solidFill>
              <a:srgbClr val="002060"/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C$5,qPCR!$F$5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3"/>
          <c:order val="3"/>
          <c:tx>
            <c:strRef>
              <c:f>qPCR!$A$6</c:f>
              <c:strCache>
                <c:ptCount val="1"/>
                <c:pt idx="0">
                  <c:v>siMITF-48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C$6,qPCR!$F$6)</c:f>
              <c:numCache>
                <c:formatCode>0.00</c:formatCode>
                <c:ptCount val="2"/>
                <c:pt idx="0">
                  <c:v>0.33680839421642345</c:v>
                </c:pt>
                <c:pt idx="1">
                  <c:v>0.49654624771851874</c:v>
                </c:pt>
              </c:numCache>
            </c:numRef>
          </c:val>
        </c:ser>
        <c:ser>
          <c:idx val="4"/>
          <c:order val="4"/>
          <c:tx>
            <c:strRef>
              <c:f>qPCR!$A$7</c:f>
              <c:strCache>
                <c:ptCount val="1"/>
                <c:pt idx="0">
                  <c:v>NC-72h</c:v>
                </c:pt>
              </c:strCache>
            </c:strRef>
          </c:tx>
          <c:spPr>
            <a:solidFill>
              <a:srgbClr val="002060"/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C$7,qPCR!$F$7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5"/>
          <c:order val="5"/>
          <c:tx>
            <c:strRef>
              <c:f>qPCR!$A$8</c:f>
              <c:strCache>
                <c:ptCount val="1"/>
                <c:pt idx="0">
                  <c:v>siMITF-72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C$8,qPCR!$F$8)</c:f>
              <c:numCache>
                <c:formatCode>0.00</c:formatCode>
                <c:ptCount val="2"/>
                <c:pt idx="0">
                  <c:v>0.29118339661711379</c:v>
                </c:pt>
                <c:pt idx="1">
                  <c:v>0.20877197985709273</c:v>
                </c:pt>
              </c:numCache>
            </c:numRef>
          </c:val>
        </c:ser>
        <c:dLbls/>
        <c:axId val="41347328"/>
        <c:axId val="41357312"/>
      </c:barChart>
      <c:catAx>
        <c:axId val="41347328"/>
        <c:scaling>
          <c:orientation val="minMax"/>
        </c:scaling>
        <c:axPos val="b"/>
        <c:tickLblPos val="nextTo"/>
        <c:crossAx val="41357312"/>
        <c:crosses val="autoZero"/>
        <c:auto val="1"/>
        <c:lblAlgn val="ctr"/>
        <c:lblOffset val="100"/>
      </c:catAx>
      <c:valAx>
        <c:axId val="41357312"/>
        <c:scaling>
          <c:orientation val="minMax"/>
        </c:scaling>
        <c:axPos val="l"/>
        <c:numFmt formatCode="0.0" sourceLinked="0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41347328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500" b="1"/>
            </a:pPr>
            <a:endParaRPr lang="en-US"/>
          </a:p>
        </c:txPr>
      </c:dTable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900"/>
            </a:pPr>
            <a:r>
              <a:rPr lang="en-US" sz="900"/>
              <a:t>MLANA expression </a:t>
            </a:r>
            <a:r>
              <a:rPr lang="en-US" sz="900" baseline="0"/>
              <a:t>after siMITF transfection </a:t>
            </a:r>
            <a:endParaRPr lang="en-US" sz="900"/>
          </a:p>
        </c:rich>
      </c:tx>
      <c:layout>
        <c:manualLayout>
          <c:xMode val="edge"/>
          <c:yMode val="edge"/>
          <c:x val="0.24174611035816224"/>
          <c:y val="4.3597765414270316E-2"/>
        </c:manualLayout>
      </c:layout>
      <c:overlay val="1"/>
    </c:title>
    <c:plotArea>
      <c:layout/>
      <c:barChart>
        <c:barDir val="col"/>
        <c:grouping val="clustered"/>
        <c:ser>
          <c:idx val="0"/>
          <c:order val="0"/>
          <c:tx>
            <c:strRef>
              <c:f>qPCR!$A$3</c:f>
              <c:strCache>
                <c:ptCount val="1"/>
                <c:pt idx="0">
                  <c:v>NC-24h</c:v>
                </c:pt>
              </c:strCache>
            </c:strRef>
          </c:tx>
          <c:spPr>
            <a:solidFill>
              <a:srgbClr val="002060"/>
            </a:solidFill>
          </c:spPr>
          <c:dPt>
            <c:idx val="0"/>
          </c:dPt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D$3,qPCR!$G$3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qPCR!$A$4</c:f>
              <c:strCache>
                <c:ptCount val="1"/>
                <c:pt idx="0">
                  <c:v>siMITF-24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D$4,qPCR!$G$4)</c:f>
              <c:numCache>
                <c:formatCode>0.00</c:formatCode>
                <c:ptCount val="2"/>
                <c:pt idx="0">
                  <c:v>0.11907974973381685</c:v>
                </c:pt>
                <c:pt idx="1">
                  <c:v>0.17253966907166665</c:v>
                </c:pt>
              </c:numCache>
            </c:numRef>
          </c:val>
        </c:ser>
        <c:ser>
          <c:idx val="2"/>
          <c:order val="2"/>
          <c:tx>
            <c:strRef>
              <c:f>qPCR!$A$5</c:f>
              <c:strCache>
                <c:ptCount val="1"/>
                <c:pt idx="0">
                  <c:v>NC-48h</c:v>
                </c:pt>
              </c:strCache>
            </c:strRef>
          </c:tx>
          <c:spPr>
            <a:solidFill>
              <a:srgbClr val="002060"/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D$5,qPCR!$G$5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3"/>
          <c:order val="3"/>
          <c:tx>
            <c:strRef>
              <c:f>qPCR!$A$6</c:f>
              <c:strCache>
                <c:ptCount val="1"/>
                <c:pt idx="0">
                  <c:v>siMITF-48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D$6,qPCR!$G$6)</c:f>
              <c:numCache>
                <c:formatCode>0.00</c:formatCode>
                <c:ptCount val="2"/>
                <c:pt idx="0">
                  <c:v>8.3331167316822469E-2</c:v>
                </c:pt>
                <c:pt idx="1">
                  <c:v>0.16840419717721872</c:v>
                </c:pt>
              </c:numCache>
            </c:numRef>
          </c:val>
        </c:ser>
        <c:ser>
          <c:idx val="4"/>
          <c:order val="4"/>
          <c:tx>
            <c:strRef>
              <c:f>qPCR!$A$7</c:f>
              <c:strCache>
                <c:ptCount val="1"/>
                <c:pt idx="0">
                  <c:v>NC-72h</c:v>
                </c:pt>
              </c:strCache>
            </c:strRef>
          </c:tx>
          <c:spPr>
            <a:solidFill>
              <a:srgbClr val="002060"/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D$7,qPCR!$G$7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5"/>
          <c:order val="5"/>
          <c:tx>
            <c:strRef>
              <c:f>qPCR!$A$8</c:f>
              <c:strCache>
                <c:ptCount val="1"/>
                <c:pt idx="0">
                  <c:v>siMITF-72h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</c:spPr>
          <c:cat>
            <c:strRef>
              <c:f>qPCR!$A$12:$A$13</c:f>
              <c:strCache>
                <c:ptCount val="2"/>
                <c:pt idx="0">
                  <c:v>INVASION</c:v>
                </c:pt>
                <c:pt idx="1">
                  <c:v>MIGRATION</c:v>
                </c:pt>
              </c:strCache>
            </c:strRef>
          </c:cat>
          <c:val>
            <c:numRef>
              <c:f>(qPCR!$D$8,qPCR!$G$8)</c:f>
              <c:numCache>
                <c:formatCode>0.00</c:formatCode>
                <c:ptCount val="2"/>
                <c:pt idx="0">
                  <c:v>9.7058609408804064E-2</c:v>
                </c:pt>
                <c:pt idx="1">
                  <c:v>0.13</c:v>
                </c:pt>
              </c:numCache>
            </c:numRef>
          </c:val>
        </c:ser>
        <c:dLbls/>
        <c:axId val="41414016"/>
        <c:axId val="41424000"/>
      </c:barChart>
      <c:catAx>
        <c:axId val="41414016"/>
        <c:scaling>
          <c:orientation val="minMax"/>
        </c:scaling>
        <c:axPos val="b"/>
        <c:tickLblPos val="nextTo"/>
        <c:crossAx val="41424000"/>
        <c:crosses val="autoZero"/>
        <c:auto val="1"/>
        <c:lblAlgn val="ctr"/>
        <c:lblOffset val="100"/>
      </c:catAx>
      <c:valAx>
        <c:axId val="41424000"/>
        <c:scaling>
          <c:orientation val="minMax"/>
        </c:scaling>
        <c:axPos val="l"/>
        <c:numFmt formatCode="0.0" sourceLinked="0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41414016"/>
        <c:crosses val="autoZero"/>
        <c:crossBetween val="between"/>
      </c:valAx>
      <c:dTable>
        <c:showHorzBorder val="1"/>
        <c:showVertBorder val="1"/>
        <c:showOutline val="1"/>
        <c:showKeys val="1"/>
        <c:txPr>
          <a:bodyPr/>
          <a:lstStyle/>
          <a:p>
            <a:pPr rtl="0">
              <a:defRPr sz="500" b="1"/>
            </a:pPr>
            <a:endParaRPr lang="en-US"/>
          </a:p>
        </c:txPr>
      </c:dTable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900"/>
            </a:pPr>
            <a:r>
              <a:rPr lang="en-US" sz="900"/>
              <a:t>siMITF Effect on Migration</a:t>
            </a:r>
          </a:p>
        </c:rich>
      </c:tx>
      <c:layout>
        <c:manualLayout>
          <c:xMode val="edge"/>
          <c:yMode val="edge"/>
          <c:x val="0.33412756891558337"/>
          <c:y val="5.8621148345075036E-2"/>
        </c:manualLayout>
      </c:layout>
      <c:overlay val="1"/>
    </c:title>
    <c:plotArea>
      <c:layout/>
      <c:lineChart>
        <c:grouping val="standard"/>
        <c:ser>
          <c:idx val="4"/>
          <c:order val="0"/>
          <c:tx>
            <c:strRef>
              <c:f>'[4]RD-Excl.MIGRATION Graphs'!$G$1</c:f>
              <c:strCache>
                <c:ptCount val="1"/>
                <c:pt idx="0">
                  <c:v>NC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[4]RD-Excl.MIGRATION Graphs'!$N$3:$N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1.553566863704293</c:v>
                  </c:pt>
                  <c:pt idx="2">
                    <c:v>1.6514145451702873</c:v>
                  </c:pt>
                  <c:pt idx="3">
                    <c:v>5.9771297459566703</c:v>
                  </c:pt>
                  <c:pt idx="4">
                    <c:v>2.1879213879844981</c:v>
                  </c:pt>
                  <c:pt idx="5">
                    <c:v>3.2423756722502151</c:v>
                  </c:pt>
                  <c:pt idx="6">
                    <c:v>2.8500877179483628</c:v>
                  </c:pt>
                  <c:pt idx="7">
                    <c:v>3.4282648672469436</c:v>
                  </c:pt>
                  <c:pt idx="8">
                    <c:v>4.6563934541659915</c:v>
                  </c:pt>
                  <c:pt idx="9">
                    <c:v>4.5708861285312929</c:v>
                  </c:pt>
                  <c:pt idx="10">
                    <c:v>5.2709581671647312</c:v>
                  </c:pt>
                  <c:pt idx="11">
                    <c:v>6.6395029934475991</c:v>
                  </c:pt>
                  <c:pt idx="12">
                    <c:v>7.3632194045810699</c:v>
                  </c:pt>
                  <c:pt idx="13">
                    <c:v>7.2437559318353451</c:v>
                  </c:pt>
                  <c:pt idx="14">
                    <c:v>8.144016208235362</c:v>
                  </c:pt>
                  <c:pt idx="15">
                    <c:v>8.5107578980957967</c:v>
                  </c:pt>
                  <c:pt idx="16">
                    <c:v>9.8922697092224023</c:v>
                  </c:pt>
                  <c:pt idx="17">
                    <c:v>10.939698350503116</c:v>
                  </c:pt>
                  <c:pt idx="18">
                    <c:v>10.788187985013991</c:v>
                  </c:pt>
                  <c:pt idx="19">
                    <c:v>10.785082289903928</c:v>
                  </c:pt>
                  <c:pt idx="20">
                    <c:v>10.59447969463336</c:v>
                  </c:pt>
                  <c:pt idx="21">
                    <c:v>10.598348928017161</c:v>
                  </c:pt>
                  <c:pt idx="22">
                    <c:v>10.035586679412411</c:v>
                  </c:pt>
                  <c:pt idx="23">
                    <c:v>9.5135692565934473</c:v>
                  </c:pt>
                  <c:pt idx="24">
                    <c:v>8.9439923971345134</c:v>
                  </c:pt>
                </c:numCache>
              </c:numRef>
            </c:plus>
            <c:minus>
              <c:numRef>
                <c:f>'[4]RD-Excl.MIGRATION Graphs'!$N$3:$N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1.553566863704293</c:v>
                  </c:pt>
                  <c:pt idx="2">
                    <c:v>1.6514145451702873</c:v>
                  </c:pt>
                  <c:pt idx="3">
                    <c:v>5.9771297459566703</c:v>
                  </c:pt>
                  <c:pt idx="4">
                    <c:v>2.1879213879844981</c:v>
                  </c:pt>
                  <c:pt idx="5">
                    <c:v>3.2423756722502151</c:v>
                  </c:pt>
                  <c:pt idx="6">
                    <c:v>2.8500877179483628</c:v>
                  </c:pt>
                  <c:pt idx="7">
                    <c:v>3.4282648672469436</c:v>
                  </c:pt>
                  <c:pt idx="8">
                    <c:v>4.6563934541659915</c:v>
                  </c:pt>
                  <c:pt idx="9">
                    <c:v>4.5708861285312929</c:v>
                  </c:pt>
                  <c:pt idx="10">
                    <c:v>5.2709581671647312</c:v>
                  </c:pt>
                  <c:pt idx="11">
                    <c:v>6.6395029934475991</c:v>
                  </c:pt>
                  <c:pt idx="12">
                    <c:v>7.3632194045810699</c:v>
                  </c:pt>
                  <c:pt idx="13">
                    <c:v>7.2437559318353451</c:v>
                  </c:pt>
                  <c:pt idx="14">
                    <c:v>8.144016208235362</c:v>
                  </c:pt>
                  <c:pt idx="15">
                    <c:v>8.5107578980957967</c:v>
                  </c:pt>
                  <c:pt idx="16">
                    <c:v>9.8922697092224023</c:v>
                  </c:pt>
                  <c:pt idx="17">
                    <c:v>10.939698350503116</c:v>
                  </c:pt>
                  <c:pt idx="18">
                    <c:v>10.788187985013991</c:v>
                  </c:pt>
                  <c:pt idx="19">
                    <c:v>10.785082289903928</c:v>
                  </c:pt>
                  <c:pt idx="20">
                    <c:v>10.59447969463336</c:v>
                  </c:pt>
                  <c:pt idx="21">
                    <c:v>10.598348928017161</c:v>
                  </c:pt>
                  <c:pt idx="22">
                    <c:v>10.035586679412411</c:v>
                  </c:pt>
                  <c:pt idx="23">
                    <c:v>9.5135692565934473</c:v>
                  </c:pt>
                  <c:pt idx="24">
                    <c:v>8.9439923971345134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numRef>
              <c:f>'[4]RD-Excl.MIGRATION Graphs'!$B$3:$B$27</c:f>
              <c:numCache>
                <c:formatCode>General</c:formatCode>
                <c:ptCount val="25"/>
                <c:pt idx="0">
                  <c:v>0</c:v>
                </c:pt>
                <c:pt idx="2">
                  <c:v>6</c:v>
                </c:pt>
                <c:pt idx="4">
                  <c:v>12</c:v>
                </c:pt>
                <c:pt idx="6">
                  <c:v>18</c:v>
                </c:pt>
                <c:pt idx="8">
                  <c:v>24</c:v>
                </c:pt>
                <c:pt idx="10">
                  <c:v>30</c:v>
                </c:pt>
                <c:pt idx="12">
                  <c:v>36</c:v>
                </c:pt>
                <c:pt idx="14">
                  <c:v>42</c:v>
                </c:pt>
                <c:pt idx="16">
                  <c:v>48</c:v>
                </c:pt>
                <c:pt idx="18">
                  <c:v>54</c:v>
                </c:pt>
                <c:pt idx="20">
                  <c:v>60</c:v>
                </c:pt>
                <c:pt idx="22">
                  <c:v>66</c:v>
                </c:pt>
                <c:pt idx="24">
                  <c:v>72</c:v>
                </c:pt>
              </c:numCache>
            </c:numRef>
          </c:cat>
          <c:val>
            <c:numRef>
              <c:f>'[4]RD-Excl.MIGRATION Graphs'!$G$3:$G$27</c:f>
              <c:numCache>
                <c:formatCode>General</c:formatCode>
                <c:ptCount val="25"/>
                <c:pt idx="0">
                  <c:v>0</c:v>
                </c:pt>
                <c:pt idx="1">
                  <c:v>5.3179999999999987</c:v>
                </c:pt>
                <c:pt idx="2">
                  <c:v>8.2620000000000005</c:v>
                </c:pt>
                <c:pt idx="3">
                  <c:v>12.906000000000002</c:v>
                </c:pt>
                <c:pt idx="4">
                  <c:v>12.820000000000002</c:v>
                </c:pt>
                <c:pt idx="5">
                  <c:v>15.66</c:v>
                </c:pt>
                <c:pt idx="6">
                  <c:v>18.759999999999994</c:v>
                </c:pt>
                <c:pt idx="7">
                  <c:v>21.660000000000004</c:v>
                </c:pt>
                <c:pt idx="8">
                  <c:v>24.68</c:v>
                </c:pt>
                <c:pt idx="9">
                  <c:v>29.759999999999998</c:v>
                </c:pt>
                <c:pt idx="10">
                  <c:v>34.340000000000003</c:v>
                </c:pt>
                <c:pt idx="11">
                  <c:v>39.040000000000006</c:v>
                </c:pt>
                <c:pt idx="12">
                  <c:v>44.820000000000007</c:v>
                </c:pt>
                <c:pt idx="13">
                  <c:v>50.220000000000013</c:v>
                </c:pt>
                <c:pt idx="14">
                  <c:v>55.9</c:v>
                </c:pt>
                <c:pt idx="15">
                  <c:v>62.14</c:v>
                </c:pt>
                <c:pt idx="16">
                  <c:v>68.179999999999993</c:v>
                </c:pt>
                <c:pt idx="17">
                  <c:v>72.58</c:v>
                </c:pt>
                <c:pt idx="18">
                  <c:v>75.7</c:v>
                </c:pt>
                <c:pt idx="19">
                  <c:v>78.960000000000022</c:v>
                </c:pt>
                <c:pt idx="20">
                  <c:v>82.36</c:v>
                </c:pt>
                <c:pt idx="21">
                  <c:v>84.7</c:v>
                </c:pt>
                <c:pt idx="22">
                  <c:v>86.06</c:v>
                </c:pt>
                <c:pt idx="23">
                  <c:v>88.34</c:v>
                </c:pt>
                <c:pt idx="24">
                  <c:v>89.4</c:v>
                </c:pt>
              </c:numCache>
            </c:numRef>
          </c:val>
        </c:ser>
        <c:ser>
          <c:idx val="5"/>
          <c:order val="1"/>
          <c:tx>
            <c:strRef>
              <c:f>'[4]RD-Excl.MIGRATION Graphs'!$H$1</c:f>
              <c:strCache>
                <c:ptCount val="1"/>
                <c:pt idx="0">
                  <c:v>siMITF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[4]RD-Excl.MIGRATION Graphs'!$O$3:$O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0.74446849049058739</c:v>
                  </c:pt>
                  <c:pt idx="2">
                    <c:v>1.0583005244258363</c:v>
                  </c:pt>
                  <c:pt idx="3">
                    <c:v>1.4224392195567919</c:v>
                  </c:pt>
                  <c:pt idx="4">
                    <c:v>4.1789153297636172</c:v>
                  </c:pt>
                  <c:pt idx="5">
                    <c:v>3.521836642056714</c:v>
                  </c:pt>
                  <c:pt idx="6">
                    <c:v>1.1930353445448847</c:v>
                  </c:pt>
                  <c:pt idx="7">
                    <c:v>1.2583057392117922</c:v>
                  </c:pt>
                  <c:pt idx="8">
                    <c:v>2.1283796653792759</c:v>
                  </c:pt>
                  <c:pt idx="9">
                    <c:v>1.9139836293274135</c:v>
                  </c:pt>
                  <c:pt idx="10">
                    <c:v>1.9157244060668002</c:v>
                  </c:pt>
                  <c:pt idx="11">
                    <c:v>1.7953644012660308</c:v>
                  </c:pt>
                  <c:pt idx="12">
                    <c:v>2</c:v>
                  </c:pt>
                  <c:pt idx="13">
                    <c:v>2.2300971578237001</c:v>
                  </c:pt>
                  <c:pt idx="14">
                    <c:v>3.4044089061098406</c:v>
                  </c:pt>
                  <c:pt idx="15">
                    <c:v>2.8000000000000007</c:v>
                  </c:pt>
                  <c:pt idx="16">
                    <c:v>3.5921210076128194</c:v>
                  </c:pt>
                  <c:pt idx="17">
                    <c:v>5.3257237379846627</c:v>
                  </c:pt>
                  <c:pt idx="18">
                    <c:v>4.2335957923889387</c:v>
                  </c:pt>
                  <c:pt idx="19">
                    <c:v>4.1681330752908208</c:v>
                  </c:pt>
                  <c:pt idx="20">
                    <c:v>4.4836740886613669</c:v>
                  </c:pt>
                  <c:pt idx="21">
                    <c:v>5.0685303589896753</c:v>
                  </c:pt>
                  <c:pt idx="22">
                    <c:v>6.1329710037903604</c:v>
                  </c:pt>
                  <c:pt idx="23">
                    <c:v>6.8002450936222401</c:v>
                  </c:pt>
                  <c:pt idx="24">
                    <c:v>6.7500617281128177</c:v>
                  </c:pt>
                </c:numCache>
              </c:numRef>
            </c:plus>
            <c:minus>
              <c:numRef>
                <c:f>'[4]RD-Excl.MIGRATION Graphs'!$O$3:$O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0.74446849049058739</c:v>
                  </c:pt>
                  <c:pt idx="2">
                    <c:v>1.0583005244258363</c:v>
                  </c:pt>
                  <c:pt idx="3">
                    <c:v>1.4224392195567919</c:v>
                  </c:pt>
                  <c:pt idx="4">
                    <c:v>4.1789153297636172</c:v>
                  </c:pt>
                  <c:pt idx="5">
                    <c:v>3.521836642056714</c:v>
                  </c:pt>
                  <c:pt idx="6">
                    <c:v>1.1930353445448847</c:v>
                  </c:pt>
                  <c:pt idx="7">
                    <c:v>1.2583057392117922</c:v>
                  </c:pt>
                  <c:pt idx="8">
                    <c:v>2.1283796653792759</c:v>
                  </c:pt>
                  <c:pt idx="9">
                    <c:v>1.9139836293274135</c:v>
                  </c:pt>
                  <c:pt idx="10">
                    <c:v>1.9157244060668002</c:v>
                  </c:pt>
                  <c:pt idx="11">
                    <c:v>1.7953644012660308</c:v>
                  </c:pt>
                  <c:pt idx="12">
                    <c:v>2</c:v>
                  </c:pt>
                  <c:pt idx="13">
                    <c:v>2.2300971578237001</c:v>
                  </c:pt>
                  <c:pt idx="14">
                    <c:v>3.4044089061098406</c:v>
                  </c:pt>
                  <c:pt idx="15">
                    <c:v>2.8000000000000007</c:v>
                  </c:pt>
                  <c:pt idx="16">
                    <c:v>3.5921210076128194</c:v>
                  </c:pt>
                  <c:pt idx="17">
                    <c:v>5.3257237379846627</c:v>
                  </c:pt>
                  <c:pt idx="18">
                    <c:v>4.2335957923889387</c:v>
                  </c:pt>
                  <c:pt idx="19">
                    <c:v>4.1681330752908208</c:v>
                  </c:pt>
                  <c:pt idx="20">
                    <c:v>4.4836740886613669</c:v>
                  </c:pt>
                  <c:pt idx="21">
                    <c:v>5.0685303589896753</c:v>
                  </c:pt>
                  <c:pt idx="22">
                    <c:v>6.1329710037903604</c:v>
                  </c:pt>
                  <c:pt idx="23">
                    <c:v>6.8002450936222401</c:v>
                  </c:pt>
                  <c:pt idx="24">
                    <c:v>6.750061728112817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numRef>
              <c:f>'[4]RD-Excl.MIGRATION Graphs'!$B$3:$B$27</c:f>
              <c:numCache>
                <c:formatCode>General</c:formatCode>
                <c:ptCount val="25"/>
                <c:pt idx="0">
                  <c:v>0</c:v>
                </c:pt>
                <c:pt idx="2">
                  <c:v>6</c:v>
                </c:pt>
                <c:pt idx="4">
                  <c:v>12</c:v>
                </c:pt>
                <c:pt idx="6">
                  <c:v>18</c:v>
                </c:pt>
                <c:pt idx="8">
                  <c:v>24</c:v>
                </c:pt>
                <c:pt idx="10">
                  <c:v>30</c:v>
                </c:pt>
                <c:pt idx="12">
                  <c:v>36</c:v>
                </c:pt>
                <c:pt idx="14">
                  <c:v>42</c:v>
                </c:pt>
                <c:pt idx="16">
                  <c:v>48</c:v>
                </c:pt>
                <c:pt idx="18">
                  <c:v>54</c:v>
                </c:pt>
                <c:pt idx="20">
                  <c:v>60</c:v>
                </c:pt>
                <c:pt idx="22">
                  <c:v>66</c:v>
                </c:pt>
                <c:pt idx="24">
                  <c:v>72</c:v>
                </c:pt>
              </c:numCache>
            </c:numRef>
          </c:cat>
          <c:val>
            <c:numRef>
              <c:f>'[4]RD-Excl.MIGRATION Graphs'!$H$3:$H$27</c:f>
              <c:numCache>
                <c:formatCode>General</c:formatCode>
                <c:ptCount val="25"/>
                <c:pt idx="0">
                  <c:v>0</c:v>
                </c:pt>
                <c:pt idx="1">
                  <c:v>7.8866666666666676</c:v>
                </c:pt>
                <c:pt idx="2">
                  <c:v>13.200000000000001</c:v>
                </c:pt>
                <c:pt idx="3">
                  <c:v>17.133333333333329</c:v>
                </c:pt>
                <c:pt idx="4">
                  <c:v>18.533333333333324</c:v>
                </c:pt>
                <c:pt idx="5">
                  <c:v>21.033333333333324</c:v>
                </c:pt>
                <c:pt idx="6">
                  <c:v>22.466666666666669</c:v>
                </c:pt>
                <c:pt idx="7">
                  <c:v>24.633333333333329</c:v>
                </c:pt>
                <c:pt idx="8">
                  <c:v>27.900000000000002</c:v>
                </c:pt>
                <c:pt idx="9">
                  <c:v>31.133333333333329</c:v>
                </c:pt>
                <c:pt idx="10">
                  <c:v>33.6</c:v>
                </c:pt>
                <c:pt idx="11">
                  <c:v>36.066666666666642</c:v>
                </c:pt>
                <c:pt idx="12">
                  <c:v>38.800000000000011</c:v>
                </c:pt>
                <c:pt idx="13">
                  <c:v>41.333333333333336</c:v>
                </c:pt>
                <c:pt idx="14">
                  <c:v>44.600000000000009</c:v>
                </c:pt>
                <c:pt idx="15">
                  <c:v>47.600000000000009</c:v>
                </c:pt>
                <c:pt idx="16">
                  <c:v>49.733333333333334</c:v>
                </c:pt>
                <c:pt idx="17">
                  <c:v>52.533333333333331</c:v>
                </c:pt>
                <c:pt idx="18">
                  <c:v>55.333333333333336</c:v>
                </c:pt>
                <c:pt idx="19">
                  <c:v>56.733333333333348</c:v>
                </c:pt>
                <c:pt idx="20">
                  <c:v>57.833333333333336</c:v>
                </c:pt>
                <c:pt idx="21">
                  <c:v>59.20000000000001</c:v>
                </c:pt>
                <c:pt idx="22">
                  <c:v>61.033333333333331</c:v>
                </c:pt>
                <c:pt idx="23">
                  <c:v>62.233333333333334</c:v>
                </c:pt>
                <c:pt idx="24">
                  <c:v>64.633333333333326</c:v>
                </c:pt>
              </c:numCache>
            </c:numRef>
          </c:val>
        </c:ser>
        <c:dLbls/>
        <c:marker val="1"/>
        <c:axId val="41476864"/>
        <c:axId val="41478400"/>
      </c:lineChart>
      <c:catAx>
        <c:axId val="41476864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41478400"/>
        <c:crosses val="autoZero"/>
        <c:auto val="1"/>
        <c:lblAlgn val="ctr"/>
        <c:lblOffset val="100"/>
      </c:catAx>
      <c:valAx>
        <c:axId val="41478400"/>
        <c:scaling>
          <c:orientation val="minMax"/>
          <c:max val="100"/>
        </c:scaling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Wound</a:t>
                </a:r>
                <a:r>
                  <a:rPr lang="en-US" sz="800" baseline="0"/>
                  <a:t> confluency (%)</a:t>
                </a:r>
                <a:endParaRPr lang="en-US" sz="800"/>
              </a:p>
            </c:rich>
          </c:tx>
          <c:layout>
            <c:manualLayout>
              <c:xMode val="edge"/>
              <c:yMode val="edge"/>
              <c:x val="6.1396721016260793E-2"/>
              <c:y val="0.17246780700316391"/>
            </c:manualLayout>
          </c:layout>
        </c:title>
        <c:numFmt formatCode="0" sourceLinked="0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41476864"/>
        <c:crosses val="autoZero"/>
        <c:crossBetween val="between"/>
        <c:majorUnit val="20"/>
      </c:valAx>
    </c:plotArea>
    <c:legend>
      <c:legendPos val="b"/>
      <c:layout>
        <c:manualLayout>
          <c:xMode val="edge"/>
          <c:yMode val="edge"/>
          <c:x val="0.38758583681585496"/>
          <c:y val="0.8840058309389921"/>
          <c:w val="0.36297064650565947"/>
          <c:h val="9.2402921785263006E-2"/>
        </c:manualLayout>
      </c:layout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900"/>
            </a:pPr>
            <a:r>
              <a:rPr lang="en-US" sz="900" b="1" i="0" u="none" strike="noStrike" baseline="0"/>
              <a:t>siMITF </a:t>
            </a:r>
            <a:r>
              <a:rPr lang="en-US" sz="900"/>
              <a:t>Effect on Invasion</a:t>
            </a:r>
          </a:p>
        </c:rich>
      </c:tx>
      <c:layout>
        <c:manualLayout>
          <c:xMode val="edge"/>
          <c:yMode val="edge"/>
          <c:x val="0.34341043949138667"/>
          <c:y val="6.2635679814953493E-2"/>
        </c:manualLayout>
      </c:layout>
      <c:overlay val="1"/>
    </c:title>
    <c:plotArea>
      <c:layout/>
      <c:lineChart>
        <c:grouping val="standard"/>
        <c:ser>
          <c:idx val="4"/>
          <c:order val="0"/>
          <c:tx>
            <c:strRef>
              <c:f>'[4]RD-Excl. INVASION Graphs'!$G$1</c:f>
              <c:strCache>
                <c:ptCount val="1"/>
                <c:pt idx="0">
                  <c:v>NC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[4]RD-Excl. INVASION Graphs'!$N$3:$N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3.8825545714130021</c:v>
                  </c:pt>
                  <c:pt idx="2">
                    <c:v>3.910322237361008</c:v>
                  </c:pt>
                  <c:pt idx="3">
                    <c:v>3.8604468653253083</c:v>
                  </c:pt>
                  <c:pt idx="4">
                    <c:v>4.0771043646195757</c:v>
                  </c:pt>
                  <c:pt idx="5">
                    <c:v>3.9324020903259616</c:v>
                  </c:pt>
                  <c:pt idx="6">
                    <c:v>3.8946142299334325</c:v>
                  </c:pt>
                  <c:pt idx="7">
                    <c:v>3.7714294372293362</c:v>
                  </c:pt>
                  <c:pt idx="8">
                    <c:v>3.4875034050162621</c:v>
                  </c:pt>
                  <c:pt idx="9">
                    <c:v>3.3729838422382068</c:v>
                  </c:pt>
                  <c:pt idx="10">
                    <c:v>3.756061767330245</c:v>
                  </c:pt>
                  <c:pt idx="11">
                    <c:v>4.0910878748812118</c:v>
                  </c:pt>
                  <c:pt idx="12">
                    <c:v>4.4195022344150843</c:v>
                  </c:pt>
                  <c:pt idx="13">
                    <c:v>3.8377076491051207</c:v>
                  </c:pt>
                  <c:pt idx="14">
                    <c:v>4.4465717131291091</c:v>
                  </c:pt>
                  <c:pt idx="15">
                    <c:v>4.5086583370221707</c:v>
                  </c:pt>
                  <c:pt idx="16">
                    <c:v>4.9583263305272718</c:v>
                  </c:pt>
                  <c:pt idx="17">
                    <c:v>5.6249444441701018</c:v>
                  </c:pt>
                  <c:pt idx="18">
                    <c:v>5.9902420652257682</c:v>
                  </c:pt>
                  <c:pt idx="19">
                    <c:v>6.5207361547604057</c:v>
                  </c:pt>
                  <c:pt idx="20">
                    <c:v>7.1156166282340534</c:v>
                  </c:pt>
                  <c:pt idx="21">
                    <c:v>6.9094138680498967</c:v>
                  </c:pt>
                  <c:pt idx="22">
                    <c:v>7.2782552854376048</c:v>
                  </c:pt>
                  <c:pt idx="23">
                    <c:v>7.2468613895948302</c:v>
                  </c:pt>
                  <c:pt idx="24">
                    <c:v>7.4478184725461585</c:v>
                  </c:pt>
                </c:numCache>
              </c:numRef>
            </c:plus>
            <c:minus>
              <c:numRef>
                <c:f>'[4]RD-Excl. INVASION Graphs'!$N$3:$N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3.8825545714130021</c:v>
                  </c:pt>
                  <c:pt idx="2">
                    <c:v>3.910322237361008</c:v>
                  </c:pt>
                  <c:pt idx="3">
                    <c:v>3.8604468653253083</c:v>
                  </c:pt>
                  <c:pt idx="4">
                    <c:v>4.0771043646195757</c:v>
                  </c:pt>
                  <c:pt idx="5">
                    <c:v>3.9324020903259616</c:v>
                  </c:pt>
                  <c:pt idx="6">
                    <c:v>3.8946142299334325</c:v>
                  </c:pt>
                  <c:pt idx="7">
                    <c:v>3.7714294372293362</c:v>
                  </c:pt>
                  <c:pt idx="8">
                    <c:v>3.4875034050162621</c:v>
                  </c:pt>
                  <c:pt idx="9">
                    <c:v>3.3729838422382068</c:v>
                  </c:pt>
                  <c:pt idx="10">
                    <c:v>3.756061767330245</c:v>
                  </c:pt>
                  <c:pt idx="11">
                    <c:v>4.0910878748812118</c:v>
                  </c:pt>
                  <c:pt idx="12">
                    <c:v>4.4195022344150843</c:v>
                  </c:pt>
                  <c:pt idx="13">
                    <c:v>3.8377076491051207</c:v>
                  </c:pt>
                  <c:pt idx="14">
                    <c:v>4.4465717131291091</c:v>
                  </c:pt>
                  <c:pt idx="15">
                    <c:v>4.5086583370221707</c:v>
                  </c:pt>
                  <c:pt idx="16">
                    <c:v>4.9583263305272718</c:v>
                  </c:pt>
                  <c:pt idx="17">
                    <c:v>5.6249444441701018</c:v>
                  </c:pt>
                  <c:pt idx="18">
                    <c:v>5.9902420652257682</c:v>
                  </c:pt>
                  <c:pt idx="19">
                    <c:v>6.5207361547604057</c:v>
                  </c:pt>
                  <c:pt idx="20">
                    <c:v>7.1156166282340534</c:v>
                  </c:pt>
                  <c:pt idx="21">
                    <c:v>6.9094138680498967</c:v>
                  </c:pt>
                  <c:pt idx="22">
                    <c:v>7.2782552854376048</c:v>
                  </c:pt>
                  <c:pt idx="23">
                    <c:v>7.2468613895948302</c:v>
                  </c:pt>
                  <c:pt idx="24">
                    <c:v>7.4478184725461585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numRef>
              <c:f>'[4]RD-Excl. INVASION Graphs'!$B$3:$B$27</c:f>
              <c:numCache>
                <c:formatCode>General</c:formatCode>
                <c:ptCount val="25"/>
                <c:pt idx="0">
                  <c:v>0</c:v>
                </c:pt>
                <c:pt idx="2">
                  <c:v>6</c:v>
                </c:pt>
                <c:pt idx="4">
                  <c:v>12</c:v>
                </c:pt>
                <c:pt idx="6">
                  <c:v>18</c:v>
                </c:pt>
                <c:pt idx="8">
                  <c:v>24</c:v>
                </c:pt>
                <c:pt idx="10">
                  <c:v>30</c:v>
                </c:pt>
                <c:pt idx="12">
                  <c:v>36</c:v>
                </c:pt>
                <c:pt idx="14">
                  <c:v>42</c:v>
                </c:pt>
                <c:pt idx="16">
                  <c:v>48</c:v>
                </c:pt>
                <c:pt idx="18">
                  <c:v>54</c:v>
                </c:pt>
                <c:pt idx="20">
                  <c:v>60</c:v>
                </c:pt>
                <c:pt idx="22">
                  <c:v>66</c:v>
                </c:pt>
                <c:pt idx="24">
                  <c:v>72</c:v>
                </c:pt>
              </c:numCache>
            </c:numRef>
          </c:cat>
          <c:val>
            <c:numRef>
              <c:f>'[4]RD-Excl. INVASION Graphs'!$G$3:$G$27</c:f>
              <c:numCache>
                <c:formatCode>General</c:formatCode>
                <c:ptCount val="25"/>
                <c:pt idx="0">
                  <c:v>0</c:v>
                </c:pt>
                <c:pt idx="1">
                  <c:v>0.64400000000000002</c:v>
                </c:pt>
                <c:pt idx="2">
                  <c:v>2.3579999999999997</c:v>
                </c:pt>
                <c:pt idx="3">
                  <c:v>3.71</c:v>
                </c:pt>
                <c:pt idx="4">
                  <c:v>4.9760000000000018</c:v>
                </c:pt>
                <c:pt idx="5">
                  <c:v>6.1718000000000002</c:v>
                </c:pt>
                <c:pt idx="6">
                  <c:v>8.1220000000000017</c:v>
                </c:pt>
                <c:pt idx="7">
                  <c:v>9.6160000000000014</c:v>
                </c:pt>
                <c:pt idx="8">
                  <c:v>12.344000000000001</c:v>
                </c:pt>
                <c:pt idx="9">
                  <c:v>15.102</c:v>
                </c:pt>
                <c:pt idx="10">
                  <c:v>17.759999999999994</c:v>
                </c:pt>
                <c:pt idx="11">
                  <c:v>21.02</c:v>
                </c:pt>
                <c:pt idx="12">
                  <c:v>23.62</c:v>
                </c:pt>
                <c:pt idx="13">
                  <c:v>27.139999999999997</c:v>
                </c:pt>
                <c:pt idx="14">
                  <c:v>29.979999999999997</c:v>
                </c:pt>
                <c:pt idx="15">
                  <c:v>33.86</c:v>
                </c:pt>
                <c:pt idx="16">
                  <c:v>37.200000000000003</c:v>
                </c:pt>
                <c:pt idx="17">
                  <c:v>40</c:v>
                </c:pt>
                <c:pt idx="18">
                  <c:v>42.740000000000009</c:v>
                </c:pt>
                <c:pt idx="19">
                  <c:v>45.2</c:v>
                </c:pt>
                <c:pt idx="20">
                  <c:v>47.52</c:v>
                </c:pt>
                <c:pt idx="21">
                  <c:v>49.4</c:v>
                </c:pt>
                <c:pt idx="22">
                  <c:v>51.740000000000009</c:v>
                </c:pt>
                <c:pt idx="23">
                  <c:v>53.720000000000013</c:v>
                </c:pt>
                <c:pt idx="24">
                  <c:v>56</c:v>
                </c:pt>
              </c:numCache>
            </c:numRef>
          </c:val>
        </c:ser>
        <c:ser>
          <c:idx val="5"/>
          <c:order val="1"/>
          <c:tx>
            <c:strRef>
              <c:f>'[4]RD-Excl. INVASION Graphs'!$H$1</c:f>
              <c:strCache>
                <c:ptCount val="1"/>
                <c:pt idx="0">
                  <c:v>siMITF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[4]RD-Excl. INVASION Graphs'!$O$3:$O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1.3848437938386169</c:v>
                  </c:pt>
                  <c:pt idx="2">
                    <c:v>1.2215290963924406</c:v>
                  </c:pt>
                  <c:pt idx="3">
                    <c:v>2.1742814905158894</c:v>
                  </c:pt>
                  <c:pt idx="4">
                    <c:v>2.2547505405254933</c:v>
                  </c:pt>
                  <c:pt idx="5">
                    <c:v>2.3226349978705936</c:v>
                  </c:pt>
                  <c:pt idx="6">
                    <c:v>2.2571072932701566</c:v>
                  </c:pt>
                  <c:pt idx="7">
                    <c:v>2.9713016227460582</c:v>
                  </c:pt>
                  <c:pt idx="8">
                    <c:v>2.8157828988282012</c:v>
                  </c:pt>
                  <c:pt idx="9">
                    <c:v>3.0446674695276581</c:v>
                  </c:pt>
                  <c:pt idx="10">
                    <c:v>3.9310727967481567</c:v>
                  </c:pt>
                  <c:pt idx="11">
                    <c:v>3.9106691669499849</c:v>
                  </c:pt>
                  <c:pt idx="12">
                    <c:v>3.3709543653590743</c:v>
                  </c:pt>
                  <c:pt idx="13">
                    <c:v>2.6633312473917212</c:v>
                  </c:pt>
                  <c:pt idx="14">
                    <c:v>2.8571547618799547</c:v>
                  </c:pt>
                  <c:pt idx="15">
                    <c:v>3.0088757590391273</c:v>
                  </c:pt>
                  <c:pt idx="16">
                    <c:v>1.9425069712444625</c:v>
                  </c:pt>
                  <c:pt idx="17">
                    <c:v>2.1126602503321101</c:v>
                  </c:pt>
                  <c:pt idx="18">
                    <c:v>2.5813433195399118</c:v>
                  </c:pt>
                  <c:pt idx="19">
                    <c:v>2.3388031127053006</c:v>
                  </c:pt>
                  <c:pt idx="20">
                    <c:v>2.666458325194677</c:v>
                  </c:pt>
                  <c:pt idx="21">
                    <c:v>2.7153882472555062</c:v>
                  </c:pt>
                  <c:pt idx="22">
                    <c:v>3.0550504633038922</c:v>
                  </c:pt>
                  <c:pt idx="23">
                    <c:v>3.3321664624285106</c:v>
                  </c:pt>
                  <c:pt idx="24">
                    <c:v>1.9502136635080096</c:v>
                  </c:pt>
                </c:numCache>
              </c:numRef>
            </c:plus>
            <c:minus>
              <c:numRef>
                <c:f>'[4]RD-Excl. INVASION Graphs'!$O$3:$O$39</c:f>
                <c:numCache>
                  <c:formatCode>General</c:formatCode>
                  <c:ptCount val="37"/>
                  <c:pt idx="0">
                    <c:v>0</c:v>
                  </c:pt>
                  <c:pt idx="1">
                    <c:v>1.3848437938386169</c:v>
                  </c:pt>
                  <c:pt idx="2">
                    <c:v>1.2215290963924406</c:v>
                  </c:pt>
                  <c:pt idx="3">
                    <c:v>2.1742814905158894</c:v>
                  </c:pt>
                  <c:pt idx="4">
                    <c:v>2.2547505405254933</c:v>
                  </c:pt>
                  <c:pt idx="5">
                    <c:v>2.3226349978705936</c:v>
                  </c:pt>
                  <c:pt idx="6">
                    <c:v>2.2571072932701566</c:v>
                  </c:pt>
                  <c:pt idx="7">
                    <c:v>2.9713016227460582</c:v>
                  </c:pt>
                  <c:pt idx="8">
                    <c:v>2.8157828988282012</c:v>
                  </c:pt>
                  <c:pt idx="9">
                    <c:v>3.0446674695276581</c:v>
                  </c:pt>
                  <c:pt idx="10">
                    <c:v>3.9310727967481567</c:v>
                  </c:pt>
                  <c:pt idx="11">
                    <c:v>3.9106691669499849</c:v>
                  </c:pt>
                  <c:pt idx="12">
                    <c:v>3.3709543653590743</c:v>
                  </c:pt>
                  <c:pt idx="13">
                    <c:v>2.6633312473917212</c:v>
                  </c:pt>
                  <c:pt idx="14">
                    <c:v>2.8571547618799547</c:v>
                  </c:pt>
                  <c:pt idx="15">
                    <c:v>3.0088757590391273</c:v>
                  </c:pt>
                  <c:pt idx="16">
                    <c:v>1.9425069712444625</c:v>
                  </c:pt>
                  <c:pt idx="17">
                    <c:v>2.1126602503321101</c:v>
                  </c:pt>
                  <c:pt idx="18">
                    <c:v>2.5813433195399118</c:v>
                  </c:pt>
                  <c:pt idx="19">
                    <c:v>2.3388031127053006</c:v>
                  </c:pt>
                  <c:pt idx="20">
                    <c:v>2.666458325194677</c:v>
                  </c:pt>
                  <c:pt idx="21">
                    <c:v>2.7153882472555062</c:v>
                  </c:pt>
                  <c:pt idx="22">
                    <c:v>3.0550504633038922</c:v>
                  </c:pt>
                  <c:pt idx="23">
                    <c:v>3.3321664624285106</c:v>
                  </c:pt>
                  <c:pt idx="24">
                    <c:v>1.9502136635080096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numRef>
              <c:f>'[4]RD-Excl. INVASION Graphs'!$B$3:$B$27</c:f>
              <c:numCache>
                <c:formatCode>General</c:formatCode>
                <c:ptCount val="25"/>
                <c:pt idx="0">
                  <c:v>0</c:v>
                </c:pt>
                <c:pt idx="2">
                  <c:v>6</c:v>
                </c:pt>
                <c:pt idx="4">
                  <c:v>12</c:v>
                </c:pt>
                <c:pt idx="6">
                  <c:v>18</c:v>
                </c:pt>
                <c:pt idx="8">
                  <c:v>24</c:v>
                </c:pt>
                <c:pt idx="10">
                  <c:v>30</c:v>
                </c:pt>
                <c:pt idx="12">
                  <c:v>36</c:v>
                </c:pt>
                <c:pt idx="14">
                  <c:v>42</c:v>
                </c:pt>
                <c:pt idx="16">
                  <c:v>48</c:v>
                </c:pt>
                <c:pt idx="18">
                  <c:v>54</c:v>
                </c:pt>
                <c:pt idx="20">
                  <c:v>60</c:v>
                </c:pt>
                <c:pt idx="22">
                  <c:v>66</c:v>
                </c:pt>
                <c:pt idx="24">
                  <c:v>72</c:v>
                </c:pt>
              </c:numCache>
            </c:numRef>
          </c:cat>
          <c:val>
            <c:numRef>
              <c:f>'[4]RD-Excl. INVASION Graphs'!$H$3:$H$27</c:f>
              <c:numCache>
                <c:formatCode>General</c:formatCode>
                <c:ptCount val="25"/>
                <c:pt idx="0">
                  <c:v>0</c:v>
                </c:pt>
                <c:pt idx="1">
                  <c:v>0.53166666666666651</c:v>
                </c:pt>
                <c:pt idx="2">
                  <c:v>2.4133333333333336</c:v>
                </c:pt>
                <c:pt idx="3">
                  <c:v>3.9299999999999997</c:v>
                </c:pt>
                <c:pt idx="4">
                  <c:v>4.6700000000000008</c:v>
                </c:pt>
                <c:pt idx="5">
                  <c:v>6.5566666666666684</c:v>
                </c:pt>
                <c:pt idx="6">
                  <c:v>8.6533333333333342</c:v>
                </c:pt>
                <c:pt idx="7">
                  <c:v>10.823333333333332</c:v>
                </c:pt>
                <c:pt idx="8">
                  <c:v>11.823333333333332</c:v>
                </c:pt>
                <c:pt idx="9">
                  <c:v>12.700000000000001</c:v>
                </c:pt>
                <c:pt idx="10">
                  <c:v>14.633333333333333</c:v>
                </c:pt>
                <c:pt idx="11">
                  <c:v>16.066666666666666</c:v>
                </c:pt>
                <c:pt idx="12">
                  <c:v>17.433333333333323</c:v>
                </c:pt>
                <c:pt idx="13">
                  <c:v>19.133333333333329</c:v>
                </c:pt>
                <c:pt idx="14">
                  <c:v>20.233333333333324</c:v>
                </c:pt>
                <c:pt idx="15">
                  <c:v>22.233333333333324</c:v>
                </c:pt>
                <c:pt idx="16">
                  <c:v>23.966666666666669</c:v>
                </c:pt>
                <c:pt idx="17">
                  <c:v>25.766666666666666</c:v>
                </c:pt>
                <c:pt idx="18">
                  <c:v>27.733333333333324</c:v>
                </c:pt>
                <c:pt idx="19">
                  <c:v>29.5</c:v>
                </c:pt>
                <c:pt idx="20">
                  <c:v>31.700000000000003</c:v>
                </c:pt>
                <c:pt idx="21">
                  <c:v>33.43333333333333</c:v>
                </c:pt>
                <c:pt idx="22">
                  <c:v>35.066666666666642</c:v>
                </c:pt>
                <c:pt idx="23">
                  <c:v>37.033333333333331</c:v>
                </c:pt>
                <c:pt idx="24">
                  <c:v>38.466666666666647</c:v>
                </c:pt>
              </c:numCache>
            </c:numRef>
          </c:val>
        </c:ser>
        <c:dLbls/>
        <c:marker val="1"/>
        <c:axId val="41522304"/>
        <c:axId val="41523840"/>
      </c:lineChart>
      <c:catAx>
        <c:axId val="41522304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41523840"/>
        <c:crosses val="autoZero"/>
        <c:auto val="1"/>
        <c:lblAlgn val="ctr"/>
        <c:lblOffset val="100"/>
      </c:catAx>
      <c:valAx>
        <c:axId val="4152384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Wound</a:t>
                </a:r>
                <a:r>
                  <a:rPr lang="en-US" sz="800" baseline="0"/>
                  <a:t>  confluency (%)</a:t>
                </a:r>
                <a:endParaRPr lang="en-US" sz="800"/>
              </a:p>
            </c:rich>
          </c:tx>
          <c:layout>
            <c:manualLayout>
              <c:xMode val="edge"/>
              <c:yMode val="edge"/>
              <c:x val="6.5066612660474032E-2"/>
              <c:y val="0.17425862260931213"/>
            </c:manualLayout>
          </c:layout>
        </c:title>
        <c:numFmt formatCode="0" sourceLinked="0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41522304"/>
        <c:crosses val="autoZero"/>
        <c:crossBetween val="between"/>
        <c:majorUnit val="20"/>
      </c:valAx>
    </c:plotArea>
    <c:legend>
      <c:legendPos val="b"/>
      <c:layout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558</cdr:x>
      <cdr:y>0.86573</cdr:y>
    </cdr:from>
    <cdr:to>
      <cdr:x>0.75783</cdr:x>
      <cdr:y>0.96961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914400" y="1905000"/>
          <a:ext cx="1600200" cy="2286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670AA4-F788-4C3B-BDFA-FFB32AE79960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F5EB2D-ACE5-4C2E-8B94-88B0E99FD9E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F5EB2D-ACE5-4C2E-8B94-88B0E99FD9E8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3289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44716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93407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65229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67278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90565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26819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78244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50800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530522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08450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B49D6-9830-4405-B0AD-3D18DE3B905B}" type="datetimeFigureOut">
              <a:rPr lang="en-US" smtClean="0"/>
              <a:pPr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9B7BD-662B-43EE-851A-9F71E071CB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26582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381000" y="990600"/>
            <a:ext cx="2820761" cy="5124068"/>
            <a:chOff x="1065439" y="509928"/>
            <a:chExt cx="2820761" cy="5124068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966544150"/>
                </p:ext>
              </p:extLst>
            </p:nvPr>
          </p:nvGraphicFramePr>
          <p:xfrm>
            <a:off x="1065439" y="509928"/>
            <a:ext cx="2820761" cy="17477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391950059"/>
                </p:ext>
              </p:extLst>
            </p:nvPr>
          </p:nvGraphicFramePr>
          <p:xfrm>
            <a:off x="1065439" y="2198064"/>
            <a:ext cx="2820761" cy="17477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1386306184"/>
                </p:ext>
              </p:extLst>
            </p:nvPr>
          </p:nvGraphicFramePr>
          <p:xfrm>
            <a:off x="1065439" y="3886200"/>
            <a:ext cx="2820761" cy="17477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pSp>
        <p:nvGrpSpPr>
          <p:cNvPr id="17" name="Group 16"/>
          <p:cNvGrpSpPr/>
          <p:nvPr/>
        </p:nvGrpSpPr>
        <p:grpSpPr>
          <a:xfrm>
            <a:off x="3352800" y="1524000"/>
            <a:ext cx="3318138" cy="4134541"/>
            <a:chOff x="76200" y="838200"/>
            <a:chExt cx="3318138" cy="4134541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542793620"/>
                </p:ext>
              </p:extLst>
            </p:nvPr>
          </p:nvGraphicFramePr>
          <p:xfrm>
            <a:off x="76200" y="2819400"/>
            <a:ext cx="3309623" cy="21533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4" name="Chart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73021752"/>
                </p:ext>
              </p:extLst>
            </p:nvPr>
          </p:nvGraphicFramePr>
          <p:xfrm>
            <a:off x="76200" y="838200"/>
            <a:ext cx="3318138" cy="22004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>
              <a:off x="1752600" y="4574368"/>
              <a:ext cx="4507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600" b="1" dirty="0" smtClean="0"/>
                <a:t>Time (h)</a:t>
              </a:r>
              <a:endParaRPr lang="en-US" sz="600" b="1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228600" y="53340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b="1" dirty="0" smtClean="0"/>
              <a:t>A</a:t>
            </a:r>
            <a:endParaRPr lang="en-US" sz="16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760960" y="547300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600" b="1" dirty="0" smtClean="0"/>
              <a:t>B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xmlns="" val="1898513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36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ATLANTI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e MARGUE</dc:creator>
  <cp:lastModifiedBy>stephanie.kreis</cp:lastModifiedBy>
  <cp:revision>8</cp:revision>
  <cp:lastPrinted>2013-03-12T09:12:09Z</cp:lastPrinted>
  <dcterms:created xsi:type="dcterms:W3CDTF">2013-03-12T08:40:55Z</dcterms:created>
  <dcterms:modified xsi:type="dcterms:W3CDTF">2013-03-14T07:02:49Z</dcterms:modified>
</cp:coreProperties>
</file>